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E3396CF-7702-91D3-C346-1B4B41B26550}" name="Sarah Bubeck" initials="SB" userId="Sarah Bubeck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2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72" y="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E7397C-649D-4B79-8FAC-A0E73C27EB3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35D381E-A20C-4F96-BCEE-0DDA45B5001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EE67DE-2408-4E0E-AA97-0447EA8BAC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2793A-9C85-4BD3-97E0-A794DECADF95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B9CC53-2B66-45F9-BBDF-381BB41CC4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62E3AD-24E2-4A56-8968-8E5A36F094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7ED2A-C8CD-42DF-9EEA-09F2B7653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2449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F7C55E-5E67-4D91-ADF1-12BB6A2FAB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F95034-D97D-4EEA-BEE2-602E7E30EE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C48602-DC40-4068-85B8-B0E6CEB02F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2793A-9C85-4BD3-97E0-A794DECADF95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AEF085-4316-49E1-9D05-819CE77568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BFF271-5893-4FEF-86B3-3E09D4A38F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7ED2A-C8CD-42DF-9EEA-09F2B7653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784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B582A50-7534-4A0C-98FD-014624CBF9E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1D83A9-268D-409C-80BC-AB1C5952BF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2D8A45-021B-4F01-8C60-4B91DD000F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2793A-9C85-4BD3-97E0-A794DECADF95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D093D5-C932-4830-9548-0FF179424F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B5D830-5A55-4B30-B491-017063231E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7ED2A-C8CD-42DF-9EEA-09F2B7653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3887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023434-6450-4829-9EDC-8F232EE0B2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66D128-EDE0-482E-8CE6-EFA1B3B1D35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E63531-6235-4E09-A328-74AC01878B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2793A-9C85-4BD3-97E0-A794DECADF95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398562-79F4-45D3-BBCA-DD8D27033B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272899-6D1E-43B1-9978-E0211E5BF6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7ED2A-C8CD-42DF-9EEA-09F2B7653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131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3E6757-46EC-4D5A-A0FE-99717F090F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C711C7-7019-4E45-9106-D58E9868C4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0C41E3-9B28-4C9F-A7CE-8E821DEE9F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2793A-9C85-4BD3-97E0-A794DECADF95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5A910B-6ECF-417F-903E-FA59C34FA9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30AFDC-817F-4FCB-A449-28D6B2D104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7ED2A-C8CD-42DF-9EEA-09F2B7653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231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FEC1E5-B511-4886-A477-DEC06C5593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7F8D49-6A4F-4635-8B64-891476186C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18F5B0-5085-43C0-8E98-1113DAB7A7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6B4262-5180-490F-A1F5-C851F66C1C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2793A-9C85-4BD3-97E0-A794DECADF95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792127-7939-4F40-88DE-9C548B95F0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8E6597-BF26-484D-A228-FBE6386F2B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7ED2A-C8CD-42DF-9EEA-09F2B7653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500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EA20AB-3F6C-4D4E-A8D5-A75A90C09D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724339-CC3E-4FAD-9D77-60DDB7A42B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3EC9CA-FDDF-42FF-B8C2-54A476CA81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1CA3DA1-3388-48FC-8BA5-4E6586CD13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BDE7806-8DB5-4329-BFE8-84251E6DB4E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62A48E9-5F10-46A0-9FAD-BE3A92EFE5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2793A-9C85-4BD3-97E0-A794DECADF95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6E1C8A9-393B-4390-B719-5D0D3831E0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5B47365-BF4A-4045-BAA5-D61A87B817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7ED2A-C8CD-42DF-9EEA-09F2B7653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00807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9AAB3F-61C0-4691-BD7A-B69DB249EA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29AD7B6-DE57-46C2-8ACE-5C9B96538C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2793A-9C85-4BD3-97E0-A794DECADF95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89CC95D-521F-408B-9CE0-F1C92A168F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46D6A1C-8584-4B83-A574-4541C7FDA0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7ED2A-C8CD-42DF-9EEA-09F2B7653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933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97B6F15-6D8E-4FDC-AFD5-68522F8642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2793A-9C85-4BD3-97E0-A794DECADF95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84DA833-AD22-47F4-87C0-8425B8C31A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C3121C9-7482-4624-9122-6F16AFE5F6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7ED2A-C8CD-42DF-9EEA-09F2B7653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6848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263D6C-14A1-4BD6-8399-39363C8153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5C8D48A-B501-45BD-A53D-0877CE2AFA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1DC12D-74A8-45DF-B591-5664B9FF39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9A45EC-4502-4A1C-8F9D-DF1C1D80C1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2793A-9C85-4BD3-97E0-A794DECADF95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BA71D2-47BC-4E82-BDCD-17AB0F2FAC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30EE14-F4A8-40BB-B769-8D2E9F3B7F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7ED2A-C8CD-42DF-9EEA-09F2B7653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60419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15FA2D-B69A-4265-BAC6-774375EDA6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739D944-06C9-4B5C-8C34-7307482C50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5F0E96-1E01-4747-BFF7-104CE9B825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521D74-EC41-4735-B2D9-9F11B282E8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2793A-9C85-4BD3-97E0-A794DECADF95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23C289-9A46-46D3-B442-71A2ACA2F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16B83C-C236-467F-98B6-7D72B8A64A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7ED2A-C8CD-42DF-9EEA-09F2B7653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93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8BC2B5A-6A96-4DF4-8560-57DA565CD2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5960F3-E900-47E9-B572-2F23A3AF71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6335AE-450F-4AB1-9AA1-3EFDCCB4CE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42793A-9C85-4BD3-97E0-A794DECADF95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969F6E-C995-4612-92C6-E096FE015E2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5D6AC0-CF2B-44A7-BDAC-900264CA421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17ED2A-C8CD-42DF-9EEA-09F2B7653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4057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Group 31">
            <a:extLst>
              <a:ext uri="{FF2B5EF4-FFF2-40B4-BE49-F238E27FC236}">
                <a16:creationId xmlns:a16="http://schemas.microsoft.com/office/drawing/2014/main" id="{FB34ED4F-624D-4DBB-8FBD-09D1A11D3E3D}"/>
              </a:ext>
            </a:extLst>
          </p:cNvPr>
          <p:cNvGrpSpPr/>
          <p:nvPr/>
        </p:nvGrpSpPr>
        <p:grpSpPr>
          <a:xfrm>
            <a:off x="2974731" y="863701"/>
            <a:ext cx="7158058" cy="5545138"/>
            <a:chOff x="1352939" y="485775"/>
            <a:chExt cx="7158058" cy="5545138"/>
          </a:xfrm>
        </p:grpSpPr>
        <p:sp>
          <p:nvSpPr>
            <p:cNvPr id="4" name="Rectángulo 1">
              <a:extLst>
                <a:ext uri="{FF2B5EF4-FFF2-40B4-BE49-F238E27FC236}">
                  <a16:creationId xmlns:a16="http://schemas.microsoft.com/office/drawing/2014/main" id="{6E261033-A29A-4C3F-BDA4-457235FA82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2705" y="485775"/>
              <a:ext cx="2721340" cy="6826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Articles identified through electronic database search (N = 148)</a:t>
              </a:r>
              <a:endParaRPr kumimoji="0" lang="en-US" altLang="en-US" sz="11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EMBASE (n = 51); PubMed (n = 97)</a:t>
              </a:r>
              <a:endParaRPr kumimoji="0" lang="en-US" altLang="en-US" sz="11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Rectángulo redondeado 2">
              <a:extLst>
                <a:ext uri="{FF2B5EF4-FFF2-40B4-BE49-F238E27FC236}">
                  <a16:creationId xmlns:a16="http://schemas.microsoft.com/office/drawing/2014/main" id="{4D8046B6-AF46-44BB-9F3E-CEE0944FC3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2939" y="1365250"/>
              <a:ext cx="1371600" cy="1806575"/>
            </a:xfrm>
            <a:prstGeom prst="roundRect">
              <a:avLst>
                <a:gd name="adj" fmla="val 9028"/>
              </a:avLst>
            </a:prstGeom>
            <a:solidFill>
              <a:srgbClr val="CCECF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creening</a:t>
              </a:r>
              <a:endParaRPr kumimoji="0" lang="en-US" altLang="en-US" sz="1100" b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Rectángulo redondeado 3">
              <a:extLst>
                <a:ext uri="{FF2B5EF4-FFF2-40B4-BE49-F238E27FC236}">
                  <a16:creationId xmlns:a16="http://schemas.microsoft.com/office/drawing/2014/main" id="{764FA489-0E45-4074-A761-AD643700F1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2939" y="5345113"/>
              <a:ext cx="1371600" cy="685800"/>
            </a:xfrm>
            <a:prstGeom prst="roundRect">
              <a:avLst>
                <a:gd name="adj" fmla="val 12500"/>
              </a:avLst>
            </a:prstGeom>
            <a:solidFill>
              <a:srgbClr val="CCECF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Included</a:t>
              </a:r>
              <a:endParaRPr kumimoji="0" lang="en-US" altLang="en-US" sz="1100" b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Rectángulo redondeado 4">
              <a:extLst>
                <a:ext uri="{FF2B5EF4-FFF2-40B4-BE49-F238E27FC236}">
                  <a16:creationId xmlns:a16="http://schemas.microsoft.com/office/drawing/2014/main" id="{797BD0DC-BAFF-4900-81C1-A92C8A3D08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2939" y="3367088"/>
              <a:ext cx="1371600" cy="1779587"/>
            </a:xfrm>
            <a:prstGeom prst="roundRect">
              <a:avLst>
                <a:gd name="adj" fmla="val 6250"/>
              </a:avLst>
            </a:prstGeom>
            <a:solidFill>
              <a:srgbClr val="CCECF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Eligibility</a:t>
              </a:r>
              <a:endParaRPr kumimoji="0" lang="en-US" altLang="en-US" sz="1100" b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Rectángulo redondeado 5">
              <a:extLst>
                <a:ext uri="{FF2B5EF4-FFF2-40B4-BE49-F238E27FC236}">
                  <a16:creationId xmlns:a16="http://schemas.microsoft.com/office/drawing/2014/main" id="{3370E5B3-046C-42B6-ABFE-F82DB2BF3B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2939" y="485775"/>
              <a:ext cx="1371600" cy="682625"/>
            </a:xfrm>
            <a:prstGeom prst="roundRect">
              <a:avLst>
                <a:gd name="adj" fmla="val 16667"/>
              </a:avLst>
            </a:prstGeom>
            <a:solidFill>
              <a:srgbClr val="CCECF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Identification</a:t>
              </a:r>
              <a:endParaRPr kumimoji="0" lang="en-US" altLang="en-US" sz="11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Rectángulo 7">
              <a:extLst>
                <a:ext uri="{FF2B5EF4-FFF2-40B4-BE49-F238E27FC236}">
                  <a16:creationId xmlns:a16="http://schemas.microsoft.com/office/drawing/2014/main" id="{E58A4EA4-1D3B-4F09-990B-4D75B70A9F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2705" y="1657350"/>
              <a:ext cx="2721339" cy="5715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Identification of relevant papers </a:t>
              </a:r>
              <a:br>
                <a:rPr kumimoji="0" lang="en-US" altLang="en-US" sz="11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</a:br>
              <a:r>
                <a:rPr kumimoji="0" lang="en-US" altLang="en-US" sz="11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n = 114)</a:t>
              </a:r>
              <a:endParaRPr kumimoji="0" lang="en-US" altLang="en-US" sz="11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Rectángulo 12">
              <a:extLst>
                <a:ext uri="{FF2B5EF4-FFF2-40B4-BE49-F238E27FC236}">
                  <a16:creationId xmlns:a16="http://schemas.microsoft.com/office/drawing/2014/main" id="{BEC30294-0C15-4F6B-96F5-5AB5932386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2705" y="2752725"/>
              <a:ext cx="2721338" cy="60848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Articles screened by title and abstract 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n = 80)</a:t>
              </a:r>
              <a:endParaRPr kumimoji="0" lang="en-US" altLang="en-US" sz="11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ángulo 13">
              <a:extLst>
                <a:ext uri="{FF2B5EF4-FFF2-40B4-BE49-F238E27FC236}">
                  <a16:creationId xmlns:a16="http://schemas.microsoft.com/office/drawing/2014/main" id="{F9AA5FB6-7816-4CBB-BD7E-3753C89375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93284" y="3252657"/>
              <a:ext cx="2017713" cy="835664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Included relevant articles</a:t>
              </a:r>
              <a:endParaRPr kumimoji="0" lang="en-US" altLang="en-US" sz="11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71450" marR="0" lvl="0" indent="-17145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</a:pPr>
              <a:r>
                <a:rPr kumimoji="0" lang="en-US" altLang="en-US" sz="11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Diagnosis or assessment of GDM</a:t>
              </a:r>
              <a:endParaRPr kumimoji="0" lang="en-US" altLang="en-US" sz="11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71450" marR="0" lvl="0" indent="-17145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</a:pPr>
              <a:r>
                <a:rPr kumimoji="0" lang="en-US" altLang="en-US" sz="11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redictive models</a:t>
              </a:r>
              <a:endParaRPr kumimoji="0" lang="en-US" altLang="en-US" sz="11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ángulo 15">
              <a:extLst>
                <a:ext uri="{FF2B5EF4-FFF2-40B4-BE49-F238E27FC236}">
                  <a16:creationId xmlns:a16="http://schemas.microsoft.com/office/drawing/2014/main" id="{FCA5223B-F101-4225-99CE-7E6BBDC67B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2705" y="3959225"/>
              <a:ext cx="2721338" cy="56409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Full text articles assessed for eligibility 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n = 46)</a:t>
              </a:r>
              <a:endParaRPr kumimoji="0" lang="en-US" altLang="en-US" sz="11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ángulo 18">
              <a:extLst>
                <a:ext uri="{FF2B5EF4-FFF2-40B4-BE49-F238E27FC236}">
                  <a16:creationId xmlns:a16="http://schemas.microsoft.com/office/drawing/2014/main" id="{459257F9-21EB-493B-83BE-23BFA8B98E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93284" y="4510191"/>
              <a:ext cx="2017713" cy="966787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Excluded full text</a:t>
              </a:r>
              <a:br>
                <a:rPr kumimoji="0" lang="en-US" altLang="en-US" sz="11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</a:br>
              <a:r>
                <a:rPr kumimoji="0" lang="en-US" altLang="en-US" sz="11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n = 18)</a:t>
              </a:r>
              <a:endParaRPr kumimoji="0" lang="en-US" altLang="en-US" sz="11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71450" marR="0" lvl="0" indent="-17145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</a:pPr>
              <a:r>
                <a:rPr kumimoji="0" lang="en-US" altLang="en-US" sz="11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Articles of physiopathology and management guidelines</a:t>
              </a:r>
              <a:endParaRPr kumimoji="0" lang="en-US" altLang="en-US" sz="11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ángulo 19">
              <a:extLst>
                <a:ext uri="{FF2B5EF4-FFF2-40B4-BE49-F238E27FC236}">
                  <a16:creationId xmlns:a16="http://schemas.microsoft.com/office/drawing/2014/main" id="{ADD8ECBC-9B1C-4D6C-9CDD-E6FA22D1C7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2704" y="5366629"/>
              <a:ext cx="2721337" cy="616913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tudies included in this review</a:t>
              </a:r>
              <a:br>
                <a:rPr kumimoji="0" lang="en-US" altLang="en-US" sz="11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</a:br>
              <a:r>
                <a:rPr kumimoji="0" lang="en-US" altLang="en-US" sz="11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n = 28)</a:t>
              </a:r>
              <a:endParaRPr kumimoji="0" lang="en-US" altLang="en-US" sz="11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Conector recto de flecha 14">
              <a:extLst>
                <a:ext uri="{FF2B5EF4-FFF2-40B4-BE49-F238E27FC236}">
                  <a16:creationId xmlns:a16="http://schemas.microsoft.com/office/drawing/2014/main" id="{BAAC1AD4-DDA7-1F4C-9FA7-146EDC75A098}"/>
                </a:ext>
              </a:extLst>
            </p:cNvPr>
            <p:cNvCxnSpPr>
              <a:cxnSpLocks noChangeShapeType="1"/>
              <a:stCxn id="9" idx="2"/>
              <a:endCxn id="10" idx="0"/>
            </p:cNvCxnSpPr>
            <p:nvPr/>
          </p:nvCxnSpPr>
          <p:spPr bwMode="auto">
            <a:xfrm flipH="1">
              <a:off x="4433374" y="2228850"/>
              <a:ext cx="1" cy="523875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16" name="Conector recto de flecha 18">
              <a:extLst>
                <a:ext uri="{FF2B5EF4-FFF2-40B4-BE49-F238E27FC236}">
                  <a16:creationId xmlns:a16="http://schemas.microsoft.com/office/drawing/2014/main" id="{F3ED8652-FA88-014D-BF87-9495E04CAB89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4423164" y="1176746"/>
              <a:ext cx="0" cy="49022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17" name="Conector recto de flecha 19">
              <a:extLst>
                <a:ext uri="{FF2B5EF4-FFF2-40B4-BE49-F238E27FC236}">
                  <a16:creationId xmlns:a16="http://schemas.microsoft.com/office/drawing/2014/main" id="{65A12E29-0CDF-014D-B602-BA731C7BD1E5}"/>
                </a:ext>
              </a:extLst>
            </p:cNvPr>
            <p:cNvCxnSpPr>
              <a:cxnSpLocks noChangeShapeType="1"/>
              <a:stCxn id="12" idx="2"/>
              <a:endCxn id="14" idx="0"/>
            </p:cNvCxnSpPr>
            <p:nvPr/>
          </p:nvCxnSpPr>
          <p:spPr bwMode="auto">
            <a:xfrm flipH="1">
              <a:off x="4433373" y="4523320"/>
              <a:ext cx="1" cy="843309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sp>
          <p:nvSpPr>
            <p:cNvPr id="18" name="Rectangle 9">
              <a:extLst>
                <a:ext uri="{FF2B5EF4-FFF2-40B4-BE49-F238E27FC236}">
                  <a16:creationId xmlns:a16="http://schemas.microsoft.com/office/drawing/2014/main" id="{EF90BAEA-0A7B-4EDC-95D1-BB40C0D412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93284" y="1219825"/>
              <a:ext cx="2017713" cy="42545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Removed duplicate articles</a:t>
              </a:r>
              <a:br>
                <a:rPr kumimoji="0" lang="en-US" altLang="en-US" sz="11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</a:br>
              <a:r>
                <a:rPr kumimoji="0" lang="en-US" altLang="en-US" sz="11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n = 34 )</a:t>
              </a:r>
              <a:endParaRPr kumimoji="0" lang="en-US" altLang="en-US" sz="11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Conector recto de flecha 21">
              <a:extLst>
                <a:ext uri="{FF2B5EF4-FFF2-40B4-BE49-F238E27FC236}">
                  <a16:creationId xmlns:a16="http://schemas.microsoft.com/office/drawing/2014/main" id="{6CC7E09D-25F7-1D4F-BE7A-E3B42B29C593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4436604" y="1429370"/>
              <a:ext cx="2031355" cy="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sp>
          <p:nvSpPr>
            <p:cNvPr id="20" name="Rectangle 7">
              <a:extLst>
                <a:ext uri="{FF2B5EF4-FFF2-40B4-BE49-F238E27FC236}">
                  <a16:creationId xmlns:a16="http://schemas.microsoft.com/office/drawing/2014/main" id="{0075A4E0-1A24-4100-8BC5-0D7642A6A2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93284" y="1983884"/>
              <a:ext cx="2017713" cy="1067183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ctr" anchorCtr="0" compatLnSpc="1">
              <a:prstTxWarp prst="textNoShape">
                <a:avLst/>
              </a:prstTxWarp>
            </a:bodyPr>
            <a:lstStyle/>
            <a:p>
              <a:pPr lvl="0"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11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Excluded articles </a:t>
              </a:r>
              <a:r>
                <a:rPr lang="en-US" altLang="en-US" sz="11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by title </a:t>
              </a:r>
              <a:endParaRPr kumimoji="0" lang="en-US" altLang="en-US" sz="11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n = 34)</a:t>
              </a:r>
              <a:endParaRPr kumimoji="0" lang="en-US" altLang="en-US" sz="11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71450" marR="0" lvl="0" indent="-17145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</a:pPr>
              <a:r>
                <a:rPr kumimoji="0" lang="en-US" altLang="en-US" sz="11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ype 2 diabetes mellitus</a:t>
              </a:r>
              <a:endParaRPr kumimoji="0" lang="en-US" altLang="en-US" sz="11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71450" marR="0" lvl="0" indent="-17145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</a:pPr>
              <a:r>
                <a:rPr kumimoji="0" lang="en-US" altLang="en-US" sz="11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ardiovascular risk</a:t>
              </a:r>
              <a:endParaRPr kumimoji="0" lang="en-US" altLang="en-US" sz="11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71450" lvl="0" indent="-171450" algn="ctr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</a:pPr>
              <a:r>
                <a:rPr kumimoji="0" lang="en-US" altLang="en-US" sz="11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Language (not English or Spanish)</a:t>
              </a:r>
              <a:endParaRPr kumimoji="0" lang="en-US" altLang="en-US" sz="11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Conector recto de flecha 31">
              <a:extLst>
                <a:ext uri="{FF2B5EF4-FFF2-40B4-BE49-F238E27FC236}">
                  <a16:creationId xmlns:a16="http://schemas.microsoft.com/office/drawing/2014/main" id="{6CC7E09D-25F7-1D4F-BE7A-E3B42B29C593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4435819" y="2452743"/>
              <a:ext cx="2032140" cy="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22" name="Conector recto de flecha 44">
              <a:extLst>
                <a:ext uri="{FF2B5EF4-FFF2-40B4-BE49-F238E27FC236}">
                  <a16:creationId xmlns:a16="http://schemas.microsoft.com/office/drawing/2014/main" id="{6CC7E09D-25F7-1D4F-BE7A-E3B42B29C593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4435819" y="3671171"/>
              <a:ext cx="2032140" cy="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23" name="Conector recto de flecha 23">
              <a:extLst>
                <a:ext uri="{FF2B5EF4-FFF2-40B4-BE49-F238E27FC236}">
                  <a16:creationId xmlns:a16="http://schemas.microsoft.com/office/drawing/2014/main" id="{6567F3F0-61AD-4536-B9EB-817BCC08D1D7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4433373" y="4992581"/>
              <a:ext cx="2034586" cy="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24" name="Conector recto de flecha 19">
              <a:extLst>
                <a:ext uri="{FF2B5EF4-FFF2-40B4-BE49-F238E27FC236}">
                  <a16:creationId xmlns:a16="http://schemas.microsoft.com/office/drawing/2014/main" id="{FE6C7A2C-EDB6-407F-A998-5C07BE6F3EE7}"/>
                </a:ext>
              </a:extLst>
            </p:cNvPr>
            <p:cNvCxnSpPr>
              <a:cxnSpLocks noChangeShapeType="1"/>
              <a:stCxn id="10" idx="2"/>
              <a:endCxn id="12" idx="0"/>
            </p:cNvCxnSpPr>
            <p:nvPr/>
          </p:nvCxnSpPr>
          <p:spPr bwMode="auto">
            <a:xfrm>
              <a:off x="4433374" y="3361211"/>
              <a:ext cx="0" cy="598014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</p:grpSp>
      <p:sp>
        <p:nvSpPr>
          <p:cNvPr id="25" name="Rectangle 22">
            <a:extLst>
              <a:ext uri="{FF2B5EF4-FFF2-40B4-BE49-F238E27FC236}">
                <a16:creationId xmlns:a16="http://schemas.microsoft.com/office/drawing/2014/main" id="{925674EF-5F0B-406C-B416-BFE7D2D099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52939" y="28575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6" name="Rectangle 36">
            <a:extLst>
              <a:ext uri="{FF2B5EF4-FFF2-40B4-BE49-F238E27FC236}">
                <a16:creationId xmlns:a16="http://schemas.microsoft.com/office/drawing/2014/main" id="{46730D07-D30B-432D-9F5C-3C66BFFB0D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52939" y="48577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9AE2EED-AA98-4BC0-807A-60159D92AF8E}"/>
              </a:ext>
            </a:extLst>
          </p:cNvPr>
          <p:cNvSpPr txBox="1"/>
          <p:nvPr/>
        </p:nvSpPr>
        <p:spPr>
          <a:xfrm>
            <a:off x="416272" y="301110"/>
            <a:ext cx="37411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1 PRISMA flow diagram.</a:t>
            </a:r>
          </a:p>
        </p:txBody>
      </p:sp>
    </p:spTree>
    <p:extLst>
      <p:ext uri="{BB962C8B-B14F-4D97-AF65-F5344CB8AC3E}">
        <p14:creationId xmlns:p14="http://schemas.microsoft.com/office/powerpoint/2010/main" val="2285046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32</Words>
  <Application>Microsoft Office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Mary Richardson</cp:lastModifiedBy>
  <cp:revision>4</cp:revision>
  <dcterms:created xsi:type="dcterms:W3CDTF">2022-04-22T12:20:06Z</dcterms:created>
  <dcterms:modified xsi:type="dcterms:W3CDTF">2022-12-06T03:26:15Z</dcterms:modified>
</cp:coreProperties>
</file>